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2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800"/>
    <a:srgbClr val="FFFFC8"/>
    <a:srgbClr val="FFDC00"/>
    <a:srgbClr val="FFFF64"/>
    <a:srgbClr val="00FF00"/>
    <a:srgbClr val="FFC8FF"/>
    <a:srgbClr val="64FFFF"/>
    <a:srgbClr val="C8FFFF"/>
    <a:srgbClr val="FF00FF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502" autoAdjust="0"/>
    <p:restoredTop sz="94746"/>
  </p:normalViewPr>
  <p:slideViewPr>
    <p:cSldViewPr snapToGrid="0" snapToObjects="1">
      <p:cViewPr varScale="1">
        <p:scale>
          <a:sx n="124" d="100"/>
          <a:sy n="124" d="100"/>
        </p:scale>
        <p:origin x="480" y="16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5" d="100"/>
        <a:sy n="11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55A03B-9FEF-EA4F-A227-0F577A9CB87C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C5DBC-334D-324B-8458-5D5051B0CC2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686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2013</a:t>
            </a:r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912461-9941-4E85-B547-8F4D86D850E8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300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700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199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709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5715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014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184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070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033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742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775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64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93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0BFC88-1E66-2380-165E-800136435D59}"/>
              </a:ext>
            </a:extLst>
          </p:cNvPr>
          <p:cNvSpPr txBox="1"/>
          <p:nvPr/>
        </p:nvSpPr>
        <p:spPr>
          <a:xfrm>
            <a:off x="0" y="5351059"/>
            <a:ext cx="9906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Online resource 2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Nucleotide and amino acid sequences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H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</a:t>
            </a:r>
          </a:p>
          <a:p>
            <a:pPr algn="just"/>
            <a:r>
              <a:rPr lang="en-US" altLang="ja-JP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RAmy3D signal peptide and a recognition sequence of TEV protease were underlined. Blue: 6xHis-tag, Green: calmodulin, Red: IP, arrowhead: digestion site of TEV protease. </a:t>
            </a:r>
            <a:endParaRPr lang="en-US" altLang="ja-JP" sz="1800" dirty="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128D574-A921-6BF8-F246-C694C6BF2FB5}"/>
              </a:ext>
            </a:extLst>
          </p:cNvPr>
          <p:cNvSpPr txBox="1"/>
          <p:nvPr/>
        </p:nvSpPr>
        <p:spPr>
          <a:xfrm>
            <a:off x="0" y="0"/>
            <a:ext cx="8846049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GAGCTCATGAAGAACACCTCGTCACTTTGCCTCTTGCTGCTAGTCGTACTGTGCTCACTGACGTGCAATAGCGGGCAAGCGATGCATCAC  90</a:t>
            </a: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      </a:t>
            </a:r>
            <a:r>
              <a:rPr lang="en" altLang="ja-JP" sz="1200" u="sng" dirty="0">
                <a:effectLst/>
                <a:latin typeface="Courier" panose="02070309020205020404" pitchFamily="49" charset="0"/>
              </a:rPr>
              <a:t>M  K  N  T  S  S  L  C  L  L  L  L  V  V  L  C  S  L  T  C  N  S  G  Q  A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M  </a:t>
            </a:r>
            <a:r>
              <a:rPr lang="en" altLang="ja-JP" sz="1200" dirty="0">
                <a:solidFill>
                  <a:srgbClr val="0070C0"/>
                </a:solidFill>
                <a:effectLst/>
                <a:latin typeface="Courier" panose="02070309020205020404" pitchFamily="49" charset="0"/>
              </a:rPr>
              <a:t>H  H</a:t>
            </a:r>
            <a:br>
              <a:rPr lang="en" altLang="ja-JP" sz="1200" dirty="0">
                <a:effectLst/>
                <a:latin typeface="Courier" panose="02070309020205020404" pitchFamily="49" charset="0"/>
              </a:rPr>
            </a:br>
            <a:r>
              <a:rPr lang="en" altLang="ja-JP" sz="1200" dirty="0">
                <a:effectLst/>
                <a:latin typeface="Courier" panose="02070309020205020404" pitchFamily="49" charset="0"/>
              </a:rPr>
              <a:t>      RAmy3D signal peptide</a:t>
            </a:r>
          </a:p>
          <a:p>
            <a:endParaRPr lang="en" altLang="ja-JP" sz="1200" dirty="0"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CACCACCATCATGCAGACCAGCTCACCGAAGAGCAGATTGCCGAGTTCAAAGAGGCCTTCTCCCTCTTTGACAAGGATGGGGACAATACC 180</a:t>
            </a:r>
          </a:p>
          <a:p>
            <a:r>
              <a:rPr lang="en" altLang="ja-JP" sz="1200" dirty="0">
                <a:solidFill>
                  <a:srgbClr val="0070C0"/>
                </a:solidFill>
                <a:effectLst/>
                <a:latin typeface="Courier" panose="02070309020205020404" pitchFamily="49" charset="0"/>
              </a:rPr>
              <a:t>H  H  H  H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</a:t>
            </a:r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A  D  Q  L  T  E  E  Q  I  A  E  F  K  E  A  F  S  L  F  D  K  D  G  D  N  T </a:t>
            </a:r>
            <a:endParaRPr lang="en" altLang="ja-JP" sz="1200" dirty="0">
              <a:solidFill>
                <a:srgbClr val="00B050"/>
              </a:solidFill>
            </a:endParaRPr>
          </a:p>
          <a:p>
            <a:endParaRPr lang="en" altLang="ja-JP" sz="1200" dirty="0"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ATCACGACCAAAGAGCTAGGGACAGTTATGCGAAGTTTGGGTCAGAATCCAACAGAAGCCGAGTTGCAAGACATGATCAACGAGGTGGAT 27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I  T  T  K  E  L  G  T  V  M  R  S  L  G  Q  N  P  T  E  A  E  L  Q  D  M  I  N  E  V  D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</a:t>
            </a:r>
            <a:endParaRPr lang="en" altLang="ja-JP" sz="1200" dirty="0"/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GCAGATGGCAATGGCACTATCGATTTTCCGGAATTCCTCACTATGATGGCTCGGAAGATGAAGGATACGGATTCGGAGGAGGAGATACGC 36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A  D  G  N  G  T  I  D  F  P  E  F  L  T  M  M  A  R  K  M  K  D  T  D  S  E  E  E  I  R </a:t>
            </a:r>
            <a:endParaRPr lang="en" altLang="ja-JP" sz="1200" dirty="0">
              <a:solidFill>
                <a:srgbClr val="00B050"/>
              </a:solidFill>
            </a:endParaRPr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GAAGCGTTTCGCGTGTTCGACAAAGACGGAAATGGGTACATCTCTGCAGCTGAACTCAGGCACGTCATGACCAACCTTGGCGAAAAGCTG 45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E  A  F  R  V  F  D  K  D  G  N  G  Y  I  S  A  A  E  L  R  H  V  M  T  N  L  G  E  K  L </a:t>
            </a:r>
            <a:endParaRPr lang="en" altLang="ja-JP" sz="1200" dirty="0">
              <a:solidFill>
                <a:srgbClr val="00B050"/>
              </a:solidFill>
            </a:endParaRPr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ACTGACGAGGAAGTTGACGAGATGATACGGGAAGCTGACATTGATGGAGATGGCCAAGTGAACTACGAGGAGTTCGTCCAGATGATGACT 54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T  D  E  E  V  D  E  M  I  R  E  A  D  I  D  G  D  G  Q  V  N  Y  E  E  F  V  Q  M  M  T </a:t>
            </a:r>
            <a:endParaRPr lang="en" altLang="ja-JP" sz="1200" dirty="0">
              <a:solidFill>
                <a:srgbClr val="00B050"/>
              </a:solidFill>
            </a:endParaRPr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GCGAAGGGTGGCTCTGAGAACCTCTACTTCCAAGGTACCGGGTTTGGCTGCCCTTTCAACCAGGGAGCCTGTCATCGCCACTGTAGGAGC 63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A  K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G  G  S  </a:t>
            </a:r>
            <a:r>
              <a:rPr lang="en" altLang="ja-JP" sz="1200" u="sng" dirty="0">
                <a:effectLst/>
                <a:latin typeface="Courier" panose="02070309020205020404" pitchFamily="49" charset="0"/>
              </a:rPr>
              <a:t>E  N  L  Y  F  Q  G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T  </a:t>
            </a:r>
            <a:r>
              <a:rPr lang="en" altLang="ja-JP" sz="1200" dirty="0">
                <a:solidFill>
                  <a:srgbClr val="FF0000"/>
                </a:solidFill>
                <a:effectLst/>
                <a:latin typeface="Courier" panose="02070309020205020404" pitchFamily="49" charset="0"/>
              </a:rPr>
              <a:t>G  F  G  C  P  F  N  Q  G  A  C  H  R  H  C  R  S  </a:t>
            </a:r>
            <a:endParaRPr lang="en" altLang="ja-JP" sz="1200" dirty="0">
              <a:solidFill>
                <a:srgbClr val="FF0000"/>
              </a:solidFill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               TEV</a:t>
            </a:r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ATTGGCAGACGTGGAGGTTATTGTGCGGGCCTTTTCAAGCAGACATGCACGTGCTATTCCAGATGAAAGCTT                   702</a:t>
            </a:r>
          </a:p>
          <a:p>
            <a:r>
              <a:rPr lang="en" altLang="ja-JP" sz="1200" dirty="0">
                <a:solidFill>
                  <a:srgbClr val="FF0000"/>
                </a:solidFill>
                <a:effectLst/>
                <a:latin typeface="Courier" panose="02070309020205020404" pitchFamily="49" charset="0"/>
              </a:rPr>
              <a:t>I  G  R  R  G  G  Y  C  A  G  L  F  K  Q  T  C  T  C  Y  S  R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*</a:t>
            </a:r>
            <a:endParaRPr lang="en" altLang="ja-JP" sz="1200" dirty="0"/>
          </a:p>
        </p:txBody>
      </p:sp>
      <p:sp>
        <p:nvSpPr>
          <p:cNvPr id="3" name="三角形 2">
            <a:extLst>
              <a:ext uri="{FF2B5EF4-FFF2-40B4-BE49-F238E27FC236}">
                <a16:creationId xmlns:a16="http://schemas.microsoft.com/office/drawing/2014/main" id="{656B88E3-2720-47D3-5155-9958BD15E399}"/>
              </a:ext>
            </a:extLst>
          </p:cNvPr>
          <p:cNvSpPr>
            <a:spLocks/>
          </p:cNvSpPr>
          <p:nvPr/>
        </p:nvSpPr>
        <p:spPr>
          <a:xfrm>
            <a:off x="2991841" y="3863086"/>
            <a:ext cx="108000" cy="108000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93757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20</TotalTime>
  <Words>299</Words>
  <Application>Microsoft Macintosh PowerPoint</Application>
  <PresentationFormat>A4 210 x 297 mm</PresentationFormat>
  <Paragraphs>2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Yu Gothic</vt:lpstr>
      <vt:lpstr>Arial</vt:lpstr>
      <vt:lpstr>Calibri</vt:lpstr>
      <vt:lpstr>Calibri Light</vt:lpstr>
      <vt:lpstr>Courier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伊藤 幸博</cp:lastModifiedBy>
  <cp:revision>494</cp:revision>
  <dcterms:created xsi:type="dcterms:W3CDTF">2019-07-05T07:37:37Z</dcterms:created>
  <dcterms:modified xsi:type="dcterms:W3CDTF">2024-10-31T04:55:03Z</dcterms:modified>
</cp:coreProperties>
</file>